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710-4400-94CA-53B5CD77194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L$4:$L$5</c:f>
                <c:numCache>
                  <c:formatCode>General</c:formatCode>
                  <c:ptCount val="2"/>
                  <c:pt idx="0">
                    <c:v>3.5</c:v>
                  </c:pt>
                  <c:pt idx="1">
                    <c:v>7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4:$J$5</c:f>
              <c:strCache>
                <c:ptCount val="2"/>
                <c:pt idx="0">
                  <c:v>UbiCRE</c:v>
                </c:pt>
                <c:pt idx="1">
                  <c:v>UbiCRE:V600E</c:v>
                </c:pt>
              </c:strCache>
            </c:strRef>
          </c:cat>
          <c:val>
            <c:numRef>
              <c:f>Sheet1!$K$4:$K$5</c:f>
              <c:numCache>
                <c:formatCode>General</c:formatCode>
                <c:ptCount val="2"/>
                <c:pt idx="0">
                  <c:v>35.08</c:v>
                </c:pt>
                <c:pt idx="1">
                  <c:v>4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710-4400-94CA-53B5CD7719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99283520"/>
        <c:axId val="1599283936"/>
      </c:barChart>
      <c:catAx>
        <c:axId val="1599283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99283936"/>
        <c:crosses val="autoZero"/>
        <c:auto val="1"/>
        <c:lblAlgn val="ctr"/>
        <c:lblOffset val="100"/>
        <c:noMultiLvlLbl val="0"/>
      </c:catAx>
      <c:valAx>
        <c:axId val="1599283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3BP1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ci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-localizing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ith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lomeres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%)</a:t>
                </a:r>
                <a:endParaRPr lang="es-E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508243932799424E-2"/>
              <c:y val="0.107775730768486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599283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5DF-4FF5-BFE3-604DCB7DABBF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L$16:$L$17</c:f>
                <c:numCache>
                  <c:formatCode>General</c:formatCode>
                  <c:ptCount val="2"/>
                  <c:pt idx="0">
                    <c:v>3.5</c:v>
                  </c:pt>
                  <c:pt idx="1">
                    <c:v>3.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J$16:$J$17</c:f>
              <c:strCache>
                <c:ptCount val="2"/>
                <c:pt idx="0">
                  <c:v>Normal tissue</c:v>
                </c:pt>
                <c:pt idx="1">
                  <c:v>Lung Tumors</c:v>
                </c:pt>
              </c:strCache>
            </c:strRef>
          </c:cat>
          <c:val>
            <c:numRef>
              <c:f>Sheet1!$K$16:$K$17</c:f>
              <c:numCache>
                <c:formatCode>General</c:formatCode>
                <c:ptCount val="2"/>
                <c:pt idx="0">
                  <c:v>38.299999999999997</c:v>
                </c:pt>
                <c:pt idx="1">
                  <c:v>46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5DF-4FF5-BFE3-604DCB7DAB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76670960"/>
        <c:axId val="1976680944"/>
      </c:barChart>
      <c:catAx>
        <c:axId val="19766709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76680944"/>
        <c:crosses val="autoZero"/>
        <c:auto val="1"/>
        <c:lblAlgn val="ctr"/>
        <c:lblOffset val="100"/>
        <c:noMultiLvlLbl val="0"/>
      </c:catAx>
      <c:valAx>
        <c:axId val="19766809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3BP1 foci  co-localizing with telomeres</a:t>
                </a:r>
                <a:r>
                  <a:rPr lang="es-ES" sz="8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%)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976670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7" Type="http://schemas.openxmlformats.org/officeDocument/2006/relationships/image" Target="../media/image4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"/><Relationship Id="rId5" Type="http://schemas.openxmlformats.org/officeDocument/2006/relationships/chart" Target="../charts/chart2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27BE97C-02D6-4B04-B8FD-9291D925F7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7965309"/>
              </p:ext>
            </p:extLst>
          </p:nvPr>
        </p:nvGraphicFramePr>
        <p:xfrm>
          <a:off x="904299" y="5882476"/>
          <a:ext cx="2305635" cy="17462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08599DF-DD35-418A-8AF2-0370DE38FAA6}"/>
              </a:ext>
            </a:extLst>
          </p:cNvPr>
          <p:cNvSpPr txBox="1"/>
          <p:nvPr/>
        </p:nvSpPr>
        <p:spPr>
          <a:xfrm>
            <a:off x="1734978" y="6265254"/>
            <a:ext cx="749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C7B111-BFB9-4523-B89F-824B08A18D12}"/>
              </a:ext>
            </a:extLst>
          </p:cNvPr>
          <p:cNvSpPr txBox="1"/>
          <p:nvPr/>
        </p:nvSpPr>
        <p:spPr>
          <a:xfrm>
            <a:off x="2483071" y="6028080"/>
            <a:ext cx="749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8511B9F-B7BC-4C0E-9FFC-D2008DA53466}"/>
              </a:ext>
            </a:extLst>
          </p:cNvPr>
          <p:cNvCxnSpPr/>
          <p:nvPr/>
        </p:nvCxnSpPr>
        <p:spPr>
          <a:xfrm>
            <a:off x="1811926" y="6014028"/>
            <a:ext cx="99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68763FF-770E-4C6B-B4AE-B72B534B46B1}"/>
              </a:ext>
            </a:extLst>
          </p:cNvPr>
          <p:cNvSpPr txBox="1"/>
          <p:nvPr/>
        </p:nvSpPr>
        <p:spPr>
          <a:xfrm>
            <a:off x="2057100" y="5844897"/>
            <a:ext cx="979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3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090B0E1-1E2E-4BC7-A5EA-A6ECA25337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5834" y="3689462"/>
            <a:ext cx="2104100" cy="195033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F137BA6-4010-4542-BE7D-4FFE3A5A06D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5834" y="1493681"/>
            <a:ext cx="2104100" cy="195033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D2F6655-E0EE-45D4-A4A5-672948A8096D}"/>
              </a:ext>
            </a:extLst>
          </p:cNvPr>
          <p:cNvSpPr txBox="1"/>
          <p:nvPr/>
        </p:nvSpPr>
        <p:spPr>
          <a:xfrm>
            <a:off x="1057594" y="1506207"/>
            <a:ext cx="6161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s-E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l</a:t>
            </a:r>
          </a:p>
          <a:p>
            <a:r>
              <a:rPr lang="es-ES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BP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184318C-57AF-419B-867D-151D5F8E8D0C}"/>
              </a:ext>
            </a:extLst>
          </p:cNvPr>
          <p:cNvSpPr txBox="1"/>
          <p:nvPr/>
        </p:nvSpPr>
        <p:spPr>
          <a:xfrm>
            <a:off x="1047066" y="3731406"/>
            <a:ext cx="6161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s-E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l</a:t>
            </a:r>
          </a:p>
          <a:p>
            <a:r>
              <a:rPr lang="es-ES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BP1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3B29564D-BC4A-414D-8F8E-90EB57D888C4}"/>
              </a:ext>
            </a:extLst>
          </p:cNvPr>
          <p:cNvCxnSpPr/>
          <p:nvPr/>
        </p:nvCxnSpPr>
        <p:spPr>
          <a:xfrm flipH="1" flipV="1">
            <a:off x="2011307" y="2404761"/>
            <a:ext cx="120649" cy="35857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1AB264A0-C3B0-41D9-9292-38B709D1205C}"/>
              </a:ext>
            </a:extLst>
          </p:cNvPr>
          <p:cNvCxnSpPr/>
          <p:nvPr/>
        </p:nvCxnSpPr>
        <p:spPr>
          <a:xfrm flipH="1" flipV="1">
            <a:off x="1874433" y="4234119"/>
            <a:ext cx="120649" cy="35857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731">
            <a:extLst>
              <a:ext uri="{FF2B5EF4-FFF2-40B4-BE49-F238E27FC236}">
                <a16:creationId xmlns:a16="http://schemas.microsoft.com/office/drawing/2014/main" id="{5F8FC919-C615-459D-B05B-42A5DAE9C3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8" y="32794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131BCAE-7953-4118-B21E-512BE9C8BA3F}"/>
              </a:ext>
            </a:extLst>
          </p:cNvPr>
          <p:cNvSpPr txBox="1"/>
          <p:nvPr/>
        </p:nvSpPr>
        <p:spPr>
          <a:xfrm rot="16200000">
            <a:off x="353402" y="4416422"/>
            <a:ext cx="863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  <a:r>
              <a:rPr lang="en-US" sz="800" baseline="30000" dirty="0"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</a:p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01786E3-8257-411B-8410-24B8A583D067}"/>
              </a:ext>
            </a:extLst>
          </p:cNvPr>
          <p:cNvSpPr txBox="1"/>
          <p:nvPr/>
        </p:nvSpPr>
        <p:spPr>
          <a:xfrm rot="16200000">
            <a:off x="229147" y="2207217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1FA5C05-F3A3-4A44-9744-74CC2EA616EF}"/>
              </a:ext>
            </a:extLst>
          </p:cNvPr>
          <p:cNvSpPr txBox="1"/>
          <p:nvPr/>
        </p:nvSpPr>
        <p:spPr>
          <a:xfrm>
            <a:off x="1647497" y="7353328"/>
            <a:ext cx="15874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V600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28CBB80-6003-4D9F-8E96-05DB2961C372}"/>
              </a:ext>
            </a:extLst>
          </p:cNvPr>
          <p:cNvSpPr txBox="1"/>
          <p:nvPr/>
        </p:nvSpPr>
        <p:spPr>
          <a:xfrm>
            <a:off x="1426060" y="1230965"/>
            <a:ext cx="163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ormal alveolar epithelium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70058C0-E3FB-4055-8CB0-23E8E4722A97}"/>
              </a:ext>
            </a:extLst>
          </p:cNvPr>
          <p:cNvSpPr txBox="1"/>
          <p:nvPr/>
        </p:nvSpPr>
        <p:spPr>
          <a:xfrm>
            <a:off x="1402716" y="3456128"/>
            <a:ext cx="163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ormal alveolar epithelium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85F5E2F9-47AC-4F30-BB8F-300A2EA810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8938620"/>
              </p:ext>
            </p:extLst>
          </p:nvPr>
        </p:nvGraphicFramePr>
        <p:xfrm>
          <a:off x="3428611" y="5922564"/>
          <a:ext cx="2390775" cy="17462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8DBB4EC4-0BCC-44AC-AEB8-7D64039BF9CB}"/>
              </a:ext>
            </a:extLst>
          </p:cNvPr>
          <p:cNvSpPr txBox="1"/>
          <p:nvPr/>
        </p:nvSpPr>
        <p:spPr>
          <a:xfrm>
            <a:off x="4262917" y="6239931"/>
            <a:ext cx="749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CAC7DB-9EE3-4DF2-B89A-7AD45C465E9A}"/>
              </a:ext>
            </a:extLst>
          </p:cNvPr>
          <p:cNvSpPr txBox="1"/>
          <p:nvPr/>
        </p:nvSpPr>
        <p:spPr>
          <a:xfrm>
            <a:off x="5097223" y="6040689"/>
            <a:ext cx="749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4B43A49-C7B5-460E-BF5A-4E0CF41760A5}"/>
              </a:ext>
            </a:extLst>
          </p:cNvPr>
          <p:cNvCxnSpPr/>
          <p:nvPr/>
        </p:nvCxnSpPr>
        <p:spPr>
          <a:xfrm>
            <a:off x="4340575" y="6081800"/>
            <a:ext cx="99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39BAD8DC-A966-423D-B90B-8C76EFC289BE}"/>
              </a:ext>
            </a:extLst>
          </p:cNvPr>
          <p:cNvSpPr txBox="1"/>
          <p:nvPr/>
        </p:nvSpPr>
        <p:spPr>
          <a:xfrm>
            <a:off x="4559249" y="5884155"/>
            <a:ext cx="9799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9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3C0A9980-7A03-4369-BC93-A435D78F377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92851" y="1487036"/>
            <a:ext cx="2101579" cy="196909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C4E07D5-BD27-4335-8CCB-CEF99D374B0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92851" y="3671572"/>
            <a:ext cx="2101578" cy="1969092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239BC96E-42BA-4532-AFF2-2B02B0E45C5F}"/>
              </a:ext>
            </a:extLst>
          </p:cNvPr>
          <p:cNvSpPr txBox="1"/>
          <p:nvPr/>
        </p:nvSpPr>
        <p:spPr>
          <a:xfrm>
            <a:off x="3603890" y="1474510"/>
            <a:ext cx="6161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s-E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l</a:t>
            </a:r>
          </a:p>
          <a:p>
            <a:r>
              <a:rPr lang="es-ES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BP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516061C-433F-457E-A648-8432DF4D3645}"/>
              </a:ext>
            </a:extLst>
          </p:cNvPr>
          <p:cNvSpPr txBox="1"/>
          <p:nvPr/>
        </p:nvSpPr>
        <p:spPr>
          <a:xfrm>
            <a:off x="3649884" y="3661247"/>
            <a:ext cx="6161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r>
              <a:rPr lang="es-E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l</a:t>
            </a:r>
          </a:p>
          <a:p>
            <a:r>
              <a:rPr lang="es-ES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BP1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4575FEAE-F441-4B54-8A17-FCD53BBD4555}"/>
              </a:ext>
            </a:extLst>
          </p:cNvPr>
          <p:cNvCxnSpPr/>
          <p:nvPr/>
        </p:nvCxnSpPr>
        <p:spPr>
          <a:xfrm flipH="1" flipV="1">
            <a:off x="4099378" y="2490673"/>
            <a:ext cx="120649" cy="35857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3F9217B0-1C7B-47AB-A3B5-EAD39A5438DB}"/>
              </a:ext>
            </a:extLst>
          </p:cNvPr>
          <p:cNvCxnSpPr/>
          <p:nvPr/>
        </p:nvCxnSpPr>
        <p:spPr>
          <a:xfrm flipH="1" flipV="1">
            <a:off x="4979775" y="4686019"/>
            <a:ext cx="120649" cy="35857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247401B-AE7B-4596-BF82-16C7554DA997}"/>
              </a:ext>
            </a:extLst>
          </p:cNvPr>
          <p:cNvSpPr txBox="1"/>
          <p:nvPr/>
        </p:nvSpPr>
        <p:spPr>
          <a:xfrm>
            <a:off x="4129255" y="7373996"/>
            <a:ext cx="16901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Normal     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Hyperplastic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pithelium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odule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0950748-B411-4B45-AD71-B0E0831F5E09}"/>
              </a:ext>
            </a:extLst>
          </p:cNvPr>
          <p:cNvSpPr txBox="1"/>
          <p:nvPr/>
        </p:nvSpPr>
        <p:spPr>
          <a:xfrm>
            <a:off x="3983843" y="1227883"/>
            <a:ext cx="163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ormal alveolar epithelium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486B29C-1829-4797-9BD1-FA444CD60932}"/>
              </a:ext>
            </a:extLst>
          </p:cNvPr>
          <p:cNvSpPr txBox="1"/>
          <p:nvPr/>
        </p:nvSpPr>
        <p:spPr>
          <a:xfrm>
            <a:off x="4161763" y="3461337"/>
            <a:ext cx="163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yperplastic nodules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38" name="Rectangle 731">
            <a:extLst>
              <a:ext uri="{FF2B5EF4-FFF2-40B4-BE49-F238E27FC236}">
                <a16:creationId xmlns:a16="http://schemas.microsoft.com/office/drawing/2014/main" id="{712319A6-E044-4E20-B01A-B357872241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7066" y="613759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A</a:t>
            </a:r>
          </a:p>
        </p:txBody>
      </p:sp>
      <p:sp>
        <p:nvSpPr>
          <p:cNvPr id="39" name="Rectangle 731">
            <a:extLst>
              <a:ext uri="{FF2B5EF4-FFF2-40B4-BE49-F238E27FC236}">
                <a16:creationId xmlns:a16="http://schemas.microsoft.com/office/drawing/2014/main" id="{7C927F24-9FDC-4BD6-BE6F-AB1ADBC536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0789" y="613758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B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2646786" y="3378554"/>
            <a:ext cx="48660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646786" y="3163110"/>
            <a:ext cx="498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2682695" y="5542972"/>
            <a:ext cx="48660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2682695" y="5327528"/>
            <a:ext cx="498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42" name="Straight Connector 41"/>
          <p:cNvCxnSpPr/>
          <p:nvPr/>
        </p:nvCxnSpPr>
        <p:spPr>
          <a:xfrm>
            <a:off x="5256392" y="3389672"/>
            <a:ext cx="48660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5256392" y="3174228"/>
            <a:ext cx="498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  <p:cxnSp>
        <p:nvCxnSpPr>
          <p:cNvPr id="44" name="Straight Connector 43"/>
          <p:cNvCxnSpPr/>
          <p:nvPr/>
        </p:nvCxnSpPr>
        <p:spPr>
          <a:xfrm>
            <a:off x="5292301" y="5554090"/>
            <a:ext cx="48660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5292301" y="5338646"/>
            <a:ext cx="498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um</a:t>
            </a:r>
          </a:p>
        </p:txBody>
      </p:sp>
    </p:spTree>
    <p:extLst>
      <p:ext uri="{BB962C8B-B14F-4D97-AF65-F5344CB8AC3E}">
        <p14:creationId xmlns:p14="http://schemas.microsoft.com/office/powerpoint/2010/main" val="3742665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79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2:51Z</dcterms:modified>
</cp:coreProperties>
</file>